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8" d="100"/>
          <a:sy n="118" d="100"/>
        </p:scale>
        <p:origin x="370" y="8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 title="ko00561.oil_00561.png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450550" y="0"/>
            <a:ext cx="2450551" cy="2697819"/>
          </a:xfrm>
          <a:prstGeom prst="rect">
            <a:avLst/>
          </a:prstGeom>
          <a:noFill/>
          <a:ln>
            <a:noFill/>
          </a:ln>
        </p:spPr>
      </p:pic>
      <p:pic>
        <p:nvPicPr>
          <p:cNvPr id="55" name="Google Shape;55;p13" title="ko00561.TAG_biosynthesis.png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0" y="0"/>
            <a:ext cx="2450538" cy="2697824"/>
          </a:xfrm>
          <a:prstGeom prst="rect">
            <a:avLst/>
          </a:prstGeom>
          <a:noFill/>
          <a:ln>
            <a:noFill/>
          </a:ln>
        </p:spPr>
      </p:pic>
      <p:pic>
        <p:nvPicPr>
          <p:cNvPr id="56" name="Google Shape;56;p13" title="ko00564.oil_00564.png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-1" y="2697825"/>
            <a:ext cx="3635550" cy="2445674"/>
          </a:xfrm>
          <a:prstGeom prst="rect">
            <a:avLst/>
          </a:prstGeom>
          <a:noFill/>
          <a:ln>
            <a:noFill/>
          </a:ln>
        </p:spPr>
      </p:pic>
      <p:sp>
        <p:nvSpPr>
          <p:cNvPr id="57" name="Google Shape;57;p13"/>
          <p:cNvSpPr txBox="1"/>
          <p:nvPr/>
        </p:nvSpPr>
        <p:spPr>
          <a:xfrm>
            <a:off x="5005350" y="69586"/>
            <a:ext cx="3840900" cy="487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just" rtl="0">
              <a:lnSpc>
                <a:spcPct val="115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200" b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ry Figure S5</a:t>
            </a:r>
            <a: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Visualization of core lipid metabolic pathways involved in fatty acid biosynthesis, elongation, and triacylglycerol (TAG) assembly in </a:t>
            </a:r>
            <a:r>
              <a:rPr lang="en" sz="1200" i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sophocarpus tetragonolobus</a:t>
            </a:r>
            <a: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based on KEGG annotations.</a:t>
            </a:r>
            <a:b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" sz="1200" b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 Fatty Acid Elongation (KO00062):</a:t>
            </a:r>
            <a: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hows the extension of fatty acyl chains in the endoplasmic reticulum via enzymes such as ketoacyl-CoA synthase (KCS) and elongation complex components, contributing to very-long-chain fatty acid (VLCFA) production.</a:t>
            </a:r>
            <a:b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" sz="1200" b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Glycerolipid Metabolism (KO00561):</a:t>
            </a:r>
            <a: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aps intermediates from glycolysis through glycerol-3-phosphate to TAG synthesis. Key enzymes include glycerol-3-phosphate acyltransferase (GPAT), lysophosphatidic acid acyltransferase (LPAAT), and diacylglycerol acyltransferase (DGAT), which are critical for TAG accumulation.</a:t>
            </a:r>
            <a:b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" sz="1200" b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) TAG Biosynthesis (subset of KO00561):</a:t>
            </a:r>
            <a: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Zoomed-in view highlighting genes specifically involved in the final steps of TAG formation, with emphasis on potential targets for metabolic engineering (e.g., </a:t>
            </a:r>
            <a:r>
              <a:rPr lang="en" sz="1200" i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GAT1</a:t>
            </a:r>
            <a: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" sz="1200" i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DAT</a:t>
            </a:r>
            <a: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" sz="1200" i="1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LEOSIN</a:t>
            </a:r>
            <a:r>
              <a:rPr lang="en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sz="1200" dirty="0">
              <a:solidFill>
                <a:schemeClr val="dk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lvl="0" indent="0" algn="l" rtl="0">
              <a:spcBef>
                <a:spcPts val="1200"/>
              </a:spcBef>
              <a:spcAft>
                <a:spcPts val="0"/>
              </a:spcAft>
              <a:buNone/>
            </a:pPr>
            <a:endParaRPr sz="1000" dirty="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7</Words>
  <Application>Microsoft Office PowerPoint</Application>
  <PresentationFormat>On-screen Show (16:9)</PresentationFormat>
  <Paragraphs>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Simple Ligh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Kishor Tribhuvan</cp:lastModifiedBy>
  <cp:revision>3</cp:revision>
  <dcterms:modified xsi:type="dcterms:W3CDTF">2025-06-29T17:17:49Z</dcterms:modified>
</cp:coreProperties>
</file>